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51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987CC94-CC31-4FA5-8BE5-E3FBAB5949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71D2638D-25AD-4A1A-90CC-4DF67FDEE2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DE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CCC3469-414C-47A1-9BC6-D749CB46F5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87F65CD-C299-416B-A2FB-9BE76A3AD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2C61F31-D661-4483-AD1D-A17EEFE4AC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5889247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B8C55BB-2F42-4965-96AE-A553F770A9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2412399-388F-4D08-8B5D-B8E604762C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2A73EC3-FB45-4E0F-B9D0-B27CEAB1F4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4F54E02-4AA1-4757-9207-AFE2BA47E2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5150FDC-05FE-48BB-A220-FB0991EEF5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74821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02C8B7EF-DC2D-4E87-A615-2CE728FC6D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8774010-3F4F-4F44-95CA-5D46CE8A66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D4FAA89-04C3-427E-880B-2660C381D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769D7A6-AAAF-4258-8BBF-C277C2F96E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65D136B-B48B-4947-9E17-099A774F87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222579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2B397D2-5AAB-483B-A372-F50F1BF208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6781DEB-D215-4C54-A2AF-5889C28824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F9DB2CA-4C1F-455E-A381-6FEFBB5F9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F920F94-DD3C-4074-B8C1-90C0653424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54C5243-639D-4A64-9186-3ED3BC901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17820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A8AC398-BEDD-44BF-A90D-1436AFA9CF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9DBB7C9-053C-428F-9D6C-70A672ABEC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07E27D0-60BC-402A-9ACF-94FA9068F1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CA4F5CD-A877-400F-A4BE-33D24D4EE5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08A44AB-CC9D-4079-A8D9-905A23107F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81178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19621DD-750E-4D57-BBFA-163D4CF8B7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F7F552F-1F7B-40FF-88A4-B860AF07F0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578A0ED-785E-4510-A490-409B551BB4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A3BCB34-4AD0-465F-ABCC-AC71AFEC5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54B0F41-A67E-49D3-A59F-A2285AA1CB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01C47BB-E181-468A-BD2F-E89DBE79C2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963663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B9ACEE8-2390-4E76-B4C2-551FA0F1AD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668B88B-B27A-425D-AE7C-0ADDE0CE70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3911CBE4-060C-453A-A858-8AC62E0D85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B059D1D5-624F-4C99-93F4-20C7E52BC2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C1633BD6-4401-418C-9C25-BE0ACED28F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75030C62-638F-4281-A7A0-135A74A6F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048F052-03C8-40C3-8838-1D1981F29B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D14E5DB4-CE12-480C-B2B9-E95471C60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74279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35A1AF0-BA16-4DD1-9C1C-72E5246434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7604A048-40DD-40C4-8692-DFF2838570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896F6750-375F-4127-94FD-2154AADBCC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CC7876FC-7A27-4C6F-8D39-69FBAB0976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093090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CC41A74F-943E-47A5-881A-7D1110EB7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EE2CCA20-23D3-40AE-83A7-8421B09AB5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22B46119-E2D2-4591-B2D6-E3F82FBCA0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074291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FF862CB-76F8-4D1D-B7FD-6E53F5E3A8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7DFE678-AA96-4B9F-9EB1-6081D221CE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FEFB217-2D78-494D-B8BD-D2A9D42735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7BA20F1-9806-4293-A289-860CA8398D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5538547-9331-47AA-8081-8E7B49895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5664E8A-6EC1-4933-BA2D-0CE07B4CE9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0405273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3F75167-5928-42C0-8B43-975D3E6B14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9263D1E-134F-4A62-BDE0-AFC0EB7BB9D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1619512-05D9-4E99-9F7B-11A0F47C42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79C877B-FE38-4AE9-9210-B368C5ED6D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C67CE4E-61CA-468B-BCC1-0548025A1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070E2CF-97E7-43CB-8C96-190101E43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09343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DC1F003-53AD-4915-8B8D-F7033B4937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0449A1D-BFE2-4CFC-A49A-A1898FB7A2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6146537-F14C-47F5-9A57-E1C491A291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4558A83-7810-4293-B448-7DA59BD96A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744FC48-8781-4787-B1F0-4D5C742DCF8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09104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FD1BD46D-12BC-4DB6-A25F-AB8456F47D34}"/>
              </a:ext>
            </a:extLst>
          </p:cNvPr>
          <p:cNvSpPr txBox="1"/>
          <p:nvPr/>
        </p:nvSpPr>
        <p:spPr>
          <a:xfrm>
            <a:off x="59267" y="76200"/>
            <a:ext cx="695478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ource Data for Figure S4A: PU.1 Western Blot</a:t>
            </a:r>
            <a:br>
              <a:rPr lang="en-GB" b="1" dirty="0"/>
            </a:br>
            <a:endParaRPr lang="en-GB" b="1" dirty="0"/>
          </a:p>
          <a:p>
            <a:r>
              <a:rPr lang="en-GB" sz="1200" dirty="0"/>
              <a:t>#SC4 is the non-targeting control and #10 is the PU.1 shRNA. </a:t>
            </a:r>
            <a:br>
              <a:rPr lang="en-GB" sz="1200" dirty="0"/>
            </a:br>
            <a:r>
              <a:rPr lang="en-GB" sz="1200" dirty="0"/>
              <a:t>“+Dox” means that </a:t>
            </a:r>
            <a:r>
              <a:rPr lang="en-GB" sz="1200" dirty="0" err="1"/>
              <a:t>doxocycline</a:t>
            </a:r>
            <a:r>
              <a:rPr lang="en-GB" sz="1200" dirty="0"/>
              <a:t> was added to the medium to induce the DOX-controlled expression cassette.</a:t>
            </a:r>
          </a:p>
          <a:p>
            <a:r>
              <a:rPr lang="en-GB" sz="1200" dirty="0"/>
              <a:t>Only the labelled lanes on the right were used for the paper. Other lanes represent other experiments.</a:t>
            </a:r>
            <a:endParaRPr lang="en-DE" sz="1200" dirty="0"/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77A3C1EA-5AF5-4161-B158-3EEFCA4846BA}"/>
              </a:ext>
            </a:extLst>
          </p:cNvPr>
          <p:cNvSpPr txBox="1"/>
          <p:nvPr/>
        </p:nvSpPr>
        <p:spPr>
          <a:xfrm rot="18110173">
            <a:off x="5540376" y="1640093"/>
            <a:ext cx="12295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Marker</a:t>
            </a:r>
          </a:p>
        </p:txBody>
      </p:sp>
      <p:sp>
        <p:nvSpPr>
          <p:cNvPr id="11" name="Rechteck 31">
            <a:extLst>
              <a:ext uri="{FF2B5EF4-FFF2-40B4-BE49-F238E27FC236}">
                <a16:creationId xmlns:a16="http://schemas.microsoft.com/office/drawing/2014/main" id="{2130AF6C-CF49-42F4-B6CA-266A2B3585A3}"/>
              </a:ext>
            </a:extLst>
          </p:cNvPr>
          <p:cNvSpPr/>
          <p:nvPr/>
        </p:nvSpPr>
        <p:spPr>
          <a:xfrm>
            <a:off x="7591732" y="3429000"/>
            <a:ext cx="396427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de-DE" sz="800" dirty="0">
              <a:solidFill>
                <a:srgbClr val="000000"/>
              </a:solidFill>
              <a:latin typeface="AAAAA E+ Optima"/>
            </a:endParaRPr>
          </a:p>
          <a:p>
            <a:r>
              <a:rPr lang="de-DE" sz="1400" b="1" dirty="0">
                <a:solidFill>
                  <a:srgbClr val="000000"/>
                </a:solidFill>
                <a:latin typeface="AAAAA E+ Optima"/>
              </a:rPr>
              <a:t> VCP : ~90 </a:t>
            </a:r>
            <a:r>
              <a:rPr lang="de-DE" sz="1400" b="1" dirty="0" err="1">
                <a:solidFill>
                  <a:srgbClr val="000000"/>
                </a:solidFill>
                <a:latin typeface="AAAAA E+ Optima"/>
              </a:rPr>
              <a:t>kDa</a:t>
            </a:r>
            <a:endParaRPr lang="de-DE" sz="1400" b="1" dirty="0">
              <a:solidFill>
                <a:srgbClr val="000000"/>
              </a:solidFill>
              <a:latin typeface="AAAAA E+ Optima"/>
            </a:endParaRPr>
          </a:p>
          <a:p>
            <a:r>
              <a:rPr lang="de-DE" sz="1400" b="1" dirty="0">
                <a:solidFill>
                  <a:srgbClr val="000000"/>
                </a:solidFill>
                <a:latin typeface="AAAAA E+ Optima"/>
              </a:rPr>
              <a:t>1:5000, </a:t>
            </a:r>
            <a:r>
              <a:rPr lang="de-DE" sz="1400" b="1" dirty="0" err="1">
                <a:solidFill>
                  <a:srgbClr val="000000"/>
                </a:solidFill>
                <a:latin typeface="AAAAA E+ Optima"/>
              </a:rPr>
              <a:t>abcam</a:t>
            </a:r>
            <a:r>
              <a:rPr lang="de-DE" sz="1400" b="1" dirty="0">
                <a:solidFill>
                  <a:srgbClr val="000000"/>
                </a:solidFill>
                <a:latin typeface="AAAAA E+ Optima"/>
              </a:rPr>
              <a:t> ab11433</a:t>
            </a:r>
          </a:p>
        </p:txBody>
      </p:sp>
      <p:sp>
        <p:nvSpPr>
          <p:cNvPr id="12" name="Rechteck 31">
            <a:extLst>
              <a:ext uri="{FF2B5EF4-FFF2-40B4-BE49-F238E27FC236}">
                <a16:creationId xmlns:a16="http://schemas.microsoft.com/office/drawing/2014/main" id="{6F98AF74-EE2E-4F59-857B-BCF23FD32291}"/>
              </a:ext>
            </a:extLst>
          </p:cNvPr>
          <p:cNvSpPr/>
          <p:nvPr/>
        </p:nvSpPr>
        <p:spPr>
          <a:xfrm>
            <a:off x="7591732" y="4546997"/>
            <a:ext cx="3964273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de-DE" sz="1400" b="1" dirty="0">
              <a:solidFill>
                <a:srgbClr val="000000"/>
              </a:solidFill>
              <a:latin typeface="AAAAA E+ Optima"/>
            </a:endParaRPr>
          </a:p>
          <a:p>
            <a:r>
              <a:rPr lang="de-DE" sz="1400" b="1" dirty="0">
                <a:solidFill>
                  <a:srgbClr val="000000"/>
                </a:solidFill>
                <a:latin typeface="AAAAA E+ Optima"/>
              </a:rPr>
              <a:t>PU.1 : ~42 kDa</a:t>
            </a:r>
          </a:p>
          <a:p>
            <a:r>
              <a:rPr lang="de-DE" sz="1400" b="1">
                <a:solidFill>
                  <a:srgbClr val="000000"/>
                </a:solidFill>
                <a:latin typeface="AAAAA E+ Optima"/>
              </a:rPr>
              <a:t>1:1000, Santa Cruz #sc-390405X</a:t>
            </a:r>
            <a:endParaRPr lang="de-DE" sz="1400" b="1" dirty="0">
              <a:solidFill>
                <a:srgbClr val="000000"/>
              </a:solidFill>
              <a:latin typeface="AAAAA E+ Optima"/>
            </a:endParaRPr>
          </a:p>
        </p:txBody>
      </p:sp>
      <p:sp>
        <p:nvSpPr>
          <p:cNvPr id="13" name="Textfeld 22">
            <a:extLst>
              <a:ext uri="{FF2B5EF4-FFF2-40B4-BE49-F238E27FC236}">
                <a16:creationId xmlns:a16="http://schemas.microsoft.com/office/drawing/2014/main" id="{F656AD2A-949F-4220-81B6-0E62F67DAB29}"/>
              </a:ext>
            </a:extLst>
          </p:cNvPr>
          <p:cNvSpPr txBox="1"/>
          <p:nvPr/>
        </p:nvSpPr>
        <p:spPr>
          <a:xfrm rot="18110173">
            <a:off x="6063888" y="1355305"/>
            <a:ext cx="170945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Thp1 #SC4 </a:t>
            </a:r>
          </a:p>
          <a:p>
            <a:r>
              <a:rPr lang="de-DE" sz="1400" dirty="0"/>
              <a:t>+Dox</a:t>
            </a:r>
          </a:p>
        </p:txBody>
      </p:sp>
      <p:sp>
        <p:nvSpPr>
          <p:cNvPr id="14" name="Textfeld 22">
            <a:extLst>
              <a:ext uri="{FF2B5EF4-FFF2-40B4-BE49-F238E27FC236}">
                <a16:creationId xmlns:a16="http://schemas.microsoft.com/office/drawing/2014/main" id="{AC6934FC-DA99-4018-A17D-2C4944CAD3C6}"/>
              </a:ext>
            </a:extLst>
          </p:cNvPr>
          <p:cNvSpPr txBox="1"/>
          <p:nvPr/>
        </p:nvSpPr>
        <p:spPr>
          <a:xfrm rot="18110173">
            <a:off x="6674061" y="1355305"/>
            <a:ext cx="170945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Thp1 #10 </a:t>
            </a:r>
          </a:p>
          <a:p>
            <a:r>
              <a:rPr lang="de-DE" sz="1400" dirty="0"/>
              <a:t>+Dox</a:t>
            </a:r>
          </a:p>
        </p:txBody>
      </p:sp>
      <p:pic>
        <p:nvPicPr>
          <p:cNvPr id="15" name="Picture 6">
            <a:extLst>
              <a:ext uri="{FF2B5EF4-FFF2-40B4-BE49-F238E27FC236}">
                <a16:creationId xmlns:a16="http://schemas.microsoft.com/office/drawing/2014/main" id="{5F2259FB-044B-47F9-BB22-34C73C1498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25011"/>
            <a:ext cx="1426605" cy="3672749"/>
          </a:xfrm>
          <a:prstGeom prst="rect">
            <a:avLst/>
          </a:prstGeom>
        </p:spPr>
      </p:pic>
      <p:pic>
        <p:nvPicPr>
          <p:cNvPr id="16" name="Picture 2">
            <a:extLst>
              <a:ext uri="{FF2B5EF4-FFF2-40B4-BE49-F238E27FC236}">
                <a16:creationId xmlns:a16="http://schemas.microsoft.com/office/drawing/2014/main" id="{A9C2AFDD-03BC-4E05-B9BC-7B24EEAC2CA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78" r="1"/>
          <a:stretch/>
        </p:blipFill>
        <p:spPr>
          <a:xfrm>
            <a:off x="1552756" y="2702541"/>
            <a:ext cx="5933776" cy="29022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5263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0</Words>
  <Application>Microsoft Office PowerPoint</Application>
  <PresentationFormat>Breitbild</PresentationFormat>
  <Paragraphs>1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AAAA E+ Optima</vt:lpstr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lexander Bender</dc:creator>
  <cp:lastModifiedBy>Alexander Bender</cp:lastModifiedBy>
  <cp:revision>6</cp:revision>
  <dcterms:created xsi:type="dcterms:W3CDTF">2024-08-29T19:57:56Z</dcterms:created>
  <dcterms:modified xsi:type="dcterms:W3CDTF">2024-08-29T20:35:49Z</dcterms:modified>
</cp:coreProperties>
</file>